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13128E7-81C7-4701-8825-0D24AC36834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63700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29E0708-DC55-48D4-BACE-88F97EDD210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65B36AD-95D7-41B9-91FF-6299FB8E69B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128D2EA-0B35-4163-BCE8-E7F8671B96E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632D17A-FFAA-43E3-B6E2-82608FC0734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637000"/>
            <a:ext cx="591480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2FC1B74-EB2F-4826-AF2D-02A8DBEE818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5B05B1-C581-4A24-8F58-44FB97F2C4F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9BFA710-7A30-4ABA-93BC-464B8E691A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1F0B7EF-898A-4FBA-9AF6-223B5786D9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1CB517-BDA7-4E9B-9100-3143E1C29A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AA8FFFB-5992-4315-9C17-4F1C58D35F0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5ADAE9-38A4-42AF-9DB9-600D16DBB6D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zh-CN" sz="900" spc="-1" strike="noStrike">
                <a:solidFill>
                  <a:srgbClr val="898989"/>
                </a:solidFill>
                <a:latin typeface="Calibri"/>
                <a:ea typeface="等线"/>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EE1FF4F4-8638-48F0-BBC1-0C425EFB820B}" type="slidenum">
              <a:rPr b="0" lang="zh-CN" sz="900" spc="-1" strike="noStrike">
                <a:solidFill>
                  <a:srgbClr val="898989"/>
                </a:solidFill>
                <a:latin typeface="Calibri"/>
                <a:ea typeface="等线"/>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549360" y="7400880"/>
            <a:ext cx="5688000" cy="21016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200" spc="-1" strike="noStrike">
                <a:solidFill>
                  <a:srgbClr val="000000"/>
                </a:solidFill>
                <a:latin typeface="Arial"/>
                <a:ea typeface="宋体"/>
              </a:rPr>
              <a:t>Supplementary Figure 1. Computational pipeline. </a:t>
            </a:r>
            <a:r>
              <a:rPr b="0" lang="en-AU" sz="1200" spc="-1" strike="noStrike">
                <a:solidFill>
                  <a:srgbClr val="000000"/>
                </a:solidFill>
                <a:latin typeface="Arial"/>
                <a:ea typeface="宋体"/>
              </a:rPr>
              <a:t>In addition to the three NK cell functional phenotypes, bulk RNA-seq data was collected from open online resources for 21 immune and stromal cell types including five T cell subsets, two B cell subsets, two dendritic cells subsets, two macrophage subsets, eosinophils, mast cells and neutrophils, fibroblasts, endothelial and epithelial cells. Secondly, we selected marker genes by pairwise comparison and CIBERSORT to create our transcriptional signature (TS). Thirdly, we input our TS and RNA-seq matrix of TCGA cancer patients into CIBERSORT to estimate the proportion of each cell type in each patient. Finally, we performed a series of statistical analysis using the immune cell type profiles and clinical results of all TCGA cancer patients. Figure created with BioRender.com</a:t>
            </a:r>
            <a:r>
              <a:rPr b="0" lang="zh-CN" sz="1200" spc="-1" strike="noStrike">
                <a:solidFill>
                  <a:srgbClr val="000000"/>
                </a:solidFill>
                <a:latin typeface="Arial"/>
                <a:ea typeface="宋体"/>
              </a:rPr>
              <a:t>。</a:t>
            </a:r>
            <a:endParaRPr b="0" lang="en-US" sz="1200" spc="-1" strike="noStrike">
              <a:solidFill>
                <a:srgbClr val="000000"/>
              </a:solidFill>
              <a:latin typeface="Calibri"/>
            </a:endParaRPr>
          </a:p>
        </p:txBody>
      </p:sp>
      <p:pic>
        <p:nvPicPr>
          <p:cNvPr id="42" name="图片 1" descr="LGG-supfig1"/>
          <p:cNvPicPr/>
          <p:nvPr/>
        </p:nvPicPr>
        <p:blipFill>
          <a:blip r:embed="rId1"/>
          <a:stretch/>
        </p:blipFill>
        <p:spPr>
          <a:xfrm>
            <a:off x="449280" y="200160"/>
            <a:ext cx="5888160" cy="70642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2" descr=""/>
          <p:cNvPicPr/>
          <p:nvPr/>
        </p:nvPicPr>
        <p:blipFill>
          <a:blip r:embed="rId1"/>
          <a:stretch/>
        </p:blipFill>
        <p:spPr>
          <a:xfrm>
            <a:off x="1101600" y="1208160"/>
            <a:ext cx="4488120" cy="6548400"/>
          </a:xfrm>
          <a:prstGeom prst="rect">
            <a:avLst/>
          </a:prstGeom>
          <a:ln w="0">
            <a:noFill/>
          </a:ln>
        </p:spPr>
      </p:pic>
      <p:sp>
        <p:nvSpPr>
          <p:cNvPr id="44" name="TextBox 1"/>
          <p:cNvSpPr/>
          <p:nvPr/>
        </p:nvSpPr>
        <p:spPr>
          <a:xfrm>
            <a:off x="1052640" y="8010360"/>
            <a:ext cx="444960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200" spc="-1" strike="noStrike">
                <a:solidFill>
                  <a:srgbClr val="000000"/>
                </a:solidFill>
                <a:latin typeface="Arial"/>
                <a:ea typeface="宋体"/>
              </a:rPr>
              <a:t>Supplementary Figure 2. The Cell differentiation hierarchy used in marker gene selection.</a:t>
            </a:r>
            <a:r>
              <a:rPr b="0" lang="en-AU" sz="1200" spc="-1" strike="noStrike">
                <a:solidFill>
                  <a:srgbClr val="000000"/>
                </a:solidFill>
                <a:latin typeface="Arial"/>
                <a:ea typeface="宋体"/>
              </a:rPr>
              <a:t> The higher levels are differentiated from cells in the lower levels (L1 differentiates into L2, L2 differentiates into L3, and L3 differentiates into L4).</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5" name="图片 1" descr="LGG-FigSup1"/>
          <p:cNvPicPr/>
          <p:nvPr/>
        </p:nvPicPr>
        <p:blipFill>
          <a:blip r:embed="rId1"/>
          <a:stretch/>
        </p:blipFill>
        <p:spPr>
          <a:xfrm>
            <a:off x="530280" y="2144880"/>
            <a:ext cx="5923080" cy="4441680"/>
          </a:xfrm>
          <a:prstGeom prst="rect">
            <a:avLst/>
          </a:prstGeom>
          <a:ln w="0">
            <a:noFill/>
          </a:ln>
        </p:spPr>
      </p:pic>
      <p:sp>
        <p:nvSpPr>
          <p:cNvPr id="46" name="TextBox 1"/>
          <p:cNvSpPr/>
          <p:nvPr/>
        </p:nvSpPr>
        <p:spPr>
          <a:xfrm>
            <a:off x="549360" y="6899400"/>
            <a:ext cx="572904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200" spc="-1" strike="noStrike">
                <a:solidFill>
                  <a:srgbClr val="000000"/>
                </a:solidFill>
                <a:latin typeface="Arial"/>
                <a:ea typeface="宋体"/>
              </a:rPr>
              <a:t>Supplementary Figure 3. Profiles of NK and T cell subset phenotypes in LGG patients.</a:t>
            </a:r>
            <a:r>
              <a:rPr b="0" lang="en-AU" sz="1200" spc="-1" strike="noStrike">
                <a:solidFill>
                  <a:srgbClr val="000000"/>
                </a:solidFill>
                <a:latin typeface="Arial"/>
                <a:ea typeface="宋体"/>
              </a:rPr>
              <a:t> (</a:t>
            </a:r>
            <a:r>
              <a:rPr b="1" lang="en-AU" sz="1200" spc="-1" strike="noStrike">
                <a:solidFill>
                  <a:srgbClr val="000000"/>
                </a:solidFill>
                <a:latin typeface="Arial"/>
                <a:ea typeface="宋体"/>
              </a:rPr>
              <a:t>A</a:t>
            </a:r>
            <a:r>
              <a:rPr b="0" lang="en-AU" sz="1200" spc="-1" strike="noStrike">
                <a:solidFill>
                  <a:srgbClr val="000000"/>
                </a:solidFill>
                <a:latin typeface="Arial"/>
                <a:ea typeface="宋体"/>
              </a:rPr>
              <a:t>) Profiles showing original fractions of NK and T cell phenotypes in LGG tumors (</a:t>
            </a:r>
            <a:r>
              <a:rPr b="1" lang="en-AU" sz="1200" spc="-1" strike="noStrike">
                <a:solidFill>
                  <a:srgbClr val="000000"/>
                </a:solidFill>
                <a:latin typeface="Arial"/>
                <a:ea typeface="宋体"/>
              </a:rPr>
              <a:t>B</a:t>
            </a:r>
            <a:r>
              <a:rPr b="0" lang="en-AU" sz="1200" spc="-1" strike="noStrike">
                <a:solidFill>
                  <a:srgbClr val="000000"/>
                </a:solidFill>
                <a:latin typeface="Arial"/>
                <a:ea typeface="宋体"/>
              </a:rPr>
              <a:t>) Proportions of total NK and T cell abundance in LGG tumors.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7" name="图片 1" descr="LGG-FigSup2"/>
          <p:cNvPicPr/>
          <p:nvPr/>
        </p:nvPicPr>
        <p:blipFill>
          <a:blip r:embed="rId1"/>
          <a:stretch/>
        </p:blipFill>
        <p:spPr>
          <a:xfrm>
            <a:off x="479520" y="2073240"/>
            <a:ext cx="6045120" cy="3627360"/>
          </a:xfrm>
          <a:prstGeom prst="rect">
            <a:avLst/>
          </a:prstGeom>
          <a:ln w="0">
            <a:noFill/>
          </a:ln>
        </p:spPr>
      </p:pic>
      <p:sp>
        <p:nvSpPr>
          <p:cNvPr id="48" name="TextBox 1"/>
          <p:cNvSpPr/>
          <p:nvPr/>
        </p:nvSpPr>
        <p:spPr>
          <a:xfrm>
            <a:off x="476280" y="5886360"/>
            <a:ext cx="590544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200" spc="-1" strike="noStrike">
                <a:solidFill>
                  <a:srgbClr val="000000"/>
                </a:solidFill>
                <a:latin typeface="Arial"/>
                <a:ea typeface="宋体"/>
              </a:rPr>
              <a:t>Supplementary Figure 4. Kaplan-Meier curves of NK cell receptor family genes in LGG patients. </a:t>
            </a:r>
            <a:r>
              <a:rPr b="0" lang="en-AU" sz="1200" spc="-1" strike="noStrike">
                <a:solidFill>
                  <a:srgbClr val="000000"/>
                </a:solidFill>
                <a:latin typeface="Arial"/>
                <a:ea typeface="宋体"/>
              </a:rPr>
              <a:t>Survival analysis of receptor genes </a:t>
            </a:r>
            <a:r>
              <a:rPr b="0" i="1" lang="en-AU" sz="1200" spc="-1" strike="noStrike">
                <a:solidFill>
                  <a:srgbClr val="000000"/>
                </a:solidFill>
                <a:latin typeface="Arial"/>
                <a:ea typeface="宋体"/>
              </a:rPr>
              <a:t>CD226 </a:t>
            </a:r>
            <a:r>
              <a:rPr b="0" lang="en-AU" sz="1200" spc="-1" strike="noStrike">
                <a:solidFill>
                  <a:srgbClr val="000000"/>
                </a:solidFill>
                <a:latin typeface="Arial"/>
                <a:ea typeface="宋体"/>
              </a:rPr>
              <a:t>(encoding DNAM-1),</a:t>
            </a:r>
            <a:r>
              <a:rPr b="0" i="1" lang="en-AU" sz="1200" spc="-1" strike="noStrike">
                <a:solidFill>
                  <a:srgbClr val="000000"/>
                </a:solidFill>
                <a:latin typeface="Arial"/>
                <a:ea typeface="宋体"/>
              </a:rPr>
              <a:t> CD244 </a:t>
            </a:r>
            <a:r>
              <a:rPr b="0" lang="en-AU" sz="1200" spc="-1" strike="noStrike">
                <a:solidFill>
                  <a:srgbClr val="000000"/>
                </a:solidFill>
                <a:latin typeface="Arial"/>
                <a:ea typeface="宋体"/>
              </a:rPr>
              <a:t>(encoding 2B4/SLAMF4)</a:t>
            </a:r>
            <a:r>
              <a:rPr b="0" i="1" lang="en-AU" sz="1200" spc="-1" strike="noStrike">
                <a:solidFill>
                  <a:srgbClr val="000000"/>
                </a:solidFill>
                <a:latin typeface="Arial"/>
                <a:ea typeface="宋体"/>
              </a:rPr>
              <a:t>, CRTAM, KIR2DL4, NCR1</a:t>
            </a:r>
            <a:r>
              <a:rPr b="0" lang="en-AU" sz="1200" spc="-1" strike="noStrike">
                <a:solidFill>
                  <a:srgbClr val="000000"/>
                </a:solidFill>
                <a:latin typeface="Arial"/>
                <a:ea typeface="宋体"/>
              </a:rPr>
              <a:t> (encoding NKp46) and </a:t>
            </a:r>
            <a:r>
              <a:rPr b="0" i="1" lang="en-AU" sz="1200" spc="-1" strike="noStrike">
                <a:solidFill>
                  <a:srgbClr val="000000"/>
                </a:solidFill>
                <a:latin typeface="Arial"/>
                <a:ea typeface="宋体"/>
              </a:rPr>
              <a:t>NCR3</a:t>
            </a:r>
            <a:r>
              <a:rPr b="0" lang="en-AU" sz="1200" spc="-1" strike="noStrike">
                <a:solidFill>
                  <a:srgbClr val="000000"/>
                </a:solidFill>
                <a:latin typeface="Arial"/>
                <a:ea typeface="宋体"/>
              </a:rPr>
              <a:t> (encoding NKp30) in TCGA-LGG. High expression of CD226 gene is significantly related to poor survival. Low (L) and high (H) expression groups were split by median TMM normalized counts. Statistics was performed by log-rank test.</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1-08-19T05:50:33Z</dcterms:created>
  <dc:creator/>
  <dc:description/>
  <dc:language>en-US</dc:language>
  <cp:lastModifiedBy>Alexander Barrow</cp:lastModifiedBy>
  <dcterms:modified xsi:type="dcterms:W3CDTF">2021-08-23T12:48:50Z</dcterms:modified>
  <cp:revision>4</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63FBF53F2BD14A3AB9468C760062966E</vt:lpwstr>
  </property>
  <property fmtid="{D5CDD505-2E9C-101B-9397-08002B2CF9AE}" pid="3" name="KSOProductBuildVer">
    <vt:lpwstr>2052-11.1.0.10700</vt:lpwstr>
  </property>
</Properties>
</file>